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2" r:id="rId2"/>
    <p:sldId id="256" r:id="rId3"/>
    <p:sldId id="257" r:id="rId4"/>
    <p:sldId id="273" r:id="rId5"/>
    <p:sldId id="261" r:id="rId6"/>
    <p:sldId id="278" r:id="rId7"/>
    <p:sldId id="275" r:id="rId8"/>
    <p:sldId id="270" r:id="rId9"/>
    <p:sldId id="276" r:id="rId10"/>
    <p:sldId id="277" r:id="rId11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62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315F29-188D-41FB-9F5C-059C875FE9A5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F7115C-DAE1-477F-9655-6001DCBA9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915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F7115C-DAE1-477F-9655-6001DCBA96D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3736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2D22C5-4448-D664-9F66-F67B51E0C2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D9170C0-83B7-EA5D-84C5-0F6658A153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42C705-8DAA-8410-86A3-F10699BDB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28FB3D-483C-0A93-D719-E6EE42E7C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3C9648-F5F5-3EF8-8DE9-CCF0B981F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6165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1D52E1-4886-9BF3-E0E9-C8DD6B6B1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BDB3F97-CF57-31A8-D828-7B51E16670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FF4A55-6D7E-117A-4458-A96A20E14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015F23-307C-4BB6-E27C-621EDD699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7FF6A2-8797-C324-4386-C49980C46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704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961227E-A70A-6AA6-8ABF-02A9D7EA64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B2ACA09-0FAA-B006-EDF7-740D1BABD5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14ACB7-7B8D-3920-EA53-7159E8D8A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8D2239-F618-2A7D-B462-631A90273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173847-06B2-86E8-F80D-F5A7CAF4C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5041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61CA57-DBFB-05D5-6248-92C16A53B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8F58832-24E0-826D-6607-DE1F4F83D9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E73C04-A952-4AE5-CAAA-9911C5CF2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F3D49C-7AF4-0C26-BD07-8B93D0AA9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6B6352-1471-644D-4545-F330BB844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92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723953-2727-EBF8-4763-4B44C8A88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6DC2A8-A21C-011E-03B0-9727222710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8C0449-857B-D115-CC4E-0D508B52F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49A126-4ABA-F6FE-B16A-D14B5B89D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BB279E-950B-6984-84EC-D96AC14B0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492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C16899-4EEA-A399-B557-47640BF40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DAC50F0-8C4E-1633-A21B-FBCEE2DA43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8A0109-1CEE-FA28-35EE-E3A174D6C4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6448824-01FC-89A9-2F06-095533723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54888B-7AA6-4AFF-F012-6A29A2879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0391A4-92DD-3340-8814-9666D3D0C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3805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417A7B-B296-BCDC-BA6A-EEFDF4595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7DBB87A-6E5D-1A61-1014-489BF4B1F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BFB8D3-630B-C1CF-2A94-156BC2FDE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88A6DE3-B262-0913-A57B-8B66763D35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2193D61-9845-6636-429F-70D41CD027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CFEAB9D-8265-E95E-5F78-274986C21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070670A-F2B9-ECCD-2526-6070E0AE3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F788397-ECCA-9E85-EC39-AAFDDEB51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500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B33F7B-95F4-4C2B-5824-185C19DE4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ED4B753-960B-DAB5-B064-A5239DAA7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DF18F1D-C24F-2096-B176-70CF9F5C0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2E9534C-9152-B177-D509-2D0F23BC6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523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CED76E5-6C1A-593C-8B92-16E318102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DA1276A-16DB-8973-0BFF-0EF2B7F45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95555E-25A5-8173-3606-F9E61DFE1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4869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70B71F-27A1-1054-D51B-ED2613144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0F83D2-3375-F187-D44A-DDBDBDF1E0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755E926-5F2B-B52E-AE92-4CE3DA7AED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58C469F-214B-B173-2FDA-2D38535CF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6F83868-4574-E9E1-A54F-011FF1536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ECBF9FF-5C97-1E35-B73F-41535DAF4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139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CE489F-1060-32B9-847C-CF80E234E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C5D64C0-C16B-E492-7E78-36E5AF7573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31920A4-2F28-EF2B-2294-81E05E8CC7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32115A-D401-5036-5F16-1A4FCAEFC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6CAA03-06D2-D13A-6907-CD7D89B58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2B06E6-81E8-AA83-4068-5185CF67A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8113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FECC65D-CD3B-26E1-0AFD-E5DD58F04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99753E-0938-9937-13CA-F6705D0E2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A3489A-2E75-5EB2-525B-E93B9D4E9D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E49E4-284C-42FE-AC5D-E7E8FEA519EC}" type="datetimeFigureOut">
              <a:rPr lang="zh-CN" altLang="en-US" smtClean="0"/>
              <a:t>2025/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51FF73-3DF5-30EB-E49F-582E60466F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31A359-3E91-BCA8-2CAF-8B3AB777F6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C8A832-68E9-4930-AFCB-F072727F44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662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D7024E-1DEE-ABB5-7898-3AAF73842E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605D070-80E9-6DB7-17AC-A76411042ED2}"/>
              </a:ext>
            </a:extLst>
          </p:cNvPr>
          <p:cNvSpPr txBox="1"/>
          <p:nvPr/>
        </p:nvSpPr>
        <p:spPr>
          <a:xfrm>
            <a:off x="97536" y="7315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1</a:t>
            </a:r>
            <a:endParaRPr lang="zh-CN" altLang="en-US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8D8C691-8FAA-9810-B322-5C170CFE046B}"/>
              </a:ext>
            </a:extLst>
          </p:cNvPr>
          <p:cNvSpPr txBox="1"/>
          <p:nvPr/>
        </p:nvSpPr>
        <p:spPr>
          <a:xfrm>
            <a:off x="421098" y="7099397"/>
            <a:ext cx="586997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1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</a:t>
            </a:r>
            <a:r>
              <a:rPr lang="en-US" altLang="zh-CN" sz="16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MT1 identified as AAA-related candidate gene. (A and B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NA-seq </a:t>
            </a:r>
            <a:r>
              <a:rPr lang="en-US" altLang="zh-CN" sz="16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onfirms high MT1 expression in AAA .</a:t>
            </a:r>
            <a:r>
              <a:rPr lang="en-US" altLang="zh-CN" sz="16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 (C-E)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The mRNA expression levels of MT1 in various mouse models of AAA were evaluated using RT-qPCR (n = 4).</a:t>
            </a:r>
            <a:endParaRPr lang="zh-CN" altLang="en-US" sz="1600" b="1" dirty="0"/>
          </a:p>
          <a:p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E13495B-D5D5-0EDA-C80B-6C3646BBB7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36" y="585485"/>
            <a:ext cx="6553200" cy="6370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02516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AEBBC5-F07B-40BE-574F-92A6590AB8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E4DBD170-945C-D82B-5D50-FCAC763721FF}"/>
              </a:ext>
            </a:extLst>
          </p:cNvPr>
          <p:cNvSpPr txBox="1"/>
          <p:nvPr/>
        </p:nvSpPr>
        <p:spPr>
          <a:xfrm>
            <a:off x="12192" y="12192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10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0774F75-CB36-7E1E-A0E3-3EAADAF80E2F}"/>
              </a:ext>
            </a:extLst>
          </p:cNvPr>
          <p:cNvSpPr txBox="1"/>
          <p:nvPr/>
        </p:nvSpPr>
        <p:spPr>
          <a:xfrm>
            <a:off x="494013" y="7578148"/>
            <a:ext cx="586997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10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 </a:t>
            </a:r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GlycoRNA-NP-siMT1 administration prevents the adhesion of neutrophils and endothelial cells. (A)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epresentative image of Cy5 labelled neutrophils . </a:t>
            </a:r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neutrophils adhering to endothelial cells. (n = 4)</a:t>
            </a:r>
            <a:endParaRPr lang="en-US" altLang="zh-CN" sz="1600" kern="10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A84261F-CABE-1D6E-5151-DCF96F1C4C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85" y="1027430"/>
            <a:ext cx="6488830" cy="4147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9521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8C2F4AF-77E5-5A1A-A32C-992A55D7E2EC}"/>
              </a:ext>
            </a:extLst>
          </p:cNvPr>
          <p:cNvSpPr txBox="1"/>
          <p:nvPr/>
        </p:nvSpPr>
        <p:spPr>
          <a:xfrm>
            <a:off x="-12192" y="-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2</a:t>
            </a:r>
            <a:endParaRPr lang="zh-CN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DFE2CC8-C913-B695-D85F-21C24E4AFECA}"/>
              </a:ext>
            </a:extLst>
          </p:cNvPr>
          <p:cNvSpPr txBox="1"/>
          <p:nvPr/>
        </p:nvSpPr>
        <p:spPr>
          <a:xfrm>
            <a:off x="494013" y="3953861"/>
            <a:ext cx="586997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2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NETs in human AAA tissues</a:t>
            </a:r>
            <a:r>
              <a:rPr lang="en-US" altLang="zh-CN" sz="16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A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AAA sections were subjected to IF staining for detecting CitH3 (red, NET marker) and α-SMA (green, VSMC marker) expression, and the nuclei were counterstained with DAPI. Scale bar = 100 </a:t>
            </a:r>
            <a:r>
              <a:rPr lang="en-US" altLang="zh-CN" sz="16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μm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CitH3 MFI (n = 8).</a:t>
            </a:r>
            <a:endParaRPr lang="en-US" altLang="zh-CN" sz="1600" b="1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A34600B-CC51-5972-914C-01A175B754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736" y="357140"/>
            <a:ext cx="6510528" cy="3377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9417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51C01A6-DFDF-3E16-C8BA-C59D414529CC}"/>
              </a:ext>
            </a:extLst>
          </p:cNvPr>
          <p:cNvSpPr txBox="1"/>
          <p:nvPr/>
        </p:nvSpPr>
        <p:spPr>
          <a:xfrm>
            <a:off x="0" y="4642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3</a:t>
            </a:r>
            <a:endParaRPr lang="zh-CN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2FC13CA-4813-9551-D8A5-A0891D8A9210}"/>
              </a:ext>
            </a:extLst>
          </p:cNvPr>
          <p:cNvSpPr txBox="1"/>
          <p:nvPr/>
        </p:nvSpPr>
        <p:spPr>
          <a:xfrm>
            <a:off x="184404" y="7746918"/>
            <a:ext cx="648919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3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MT1 expression in mouse AAA tissues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(A) </a:t>
            </a:r>
            <a:r>
              <a:rPr lang="en-US" altLang="zh-CN" sz="14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Representative image of the sacrificed aortas. 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AAA sections were subjected to IF staining for detecting CitH3 (red, NET marker) and α-SMA (green, VSMC marker) expression, and the nuclei were counterstained with DAPI. Scale bar = 100 </a:t>
            </a:r>
            <a:r>
              <a:rPr lang="en-US" altLang="zh-CN" sz="14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μm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. 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C) 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CitH3 MFI (n = 4). 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D-G) 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mRNA expression levels of TNF-α, MMP2, ACTA2, and BAX were assessed by RT-qPCR (n = 4). 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39E7B26-8649-CE93-7502-65588DFC70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659" y="613459"/>
            <a:ext cx="6198681" cy="7005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729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8C150F-EE35-F57A-4B3F-68A113FBBFC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AF4818C-1898-ABF9-7DC5-9EE4F3AB2F51}"/>
              </a:ext>
            </a:extLst>
          </p:cNvPr>
          <p:cNvSpPr txBox="1"/>
          <p:nvPr/>
        </p:nvSpPr>
        <p:spPr>
          <a:xfrm>
            <a:off x="0" y="4642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4</a:t>
            </a:r>
            <a:endParaRPr lang="zh-CN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5F24C57-A423-BE66-5E89-5ECD38006E1F}"/>
              </a:ext>
            </a:extLst>
          </p:cNvPr>
          <p:cNvSpPr txBox="1"/>
          <p:nvPr/>
        </p:nvSpPr>
        <p:spPr>
          <a:xfrm>
            <a:off x="184404" y="7746918"/>
            <a:ext cx="648919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4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MT1 modulates the formation of NETs through the p65 NF-kB pathway.</a:t>
            </a:r>
            <a:r>
              <a:rPr lang="en-US" altLang="zh-CN" sz="14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4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Western Blot analysis of MT1, p65, and CitH3 protein expression. </a:t>
            </a:r>
            <a:r>
              <a:rPr lang="en-US" altLang="zh-CN" sz="14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-C) </a:t>
            </a:r>
            <a:r>
              <a:rPr lang="en-US" altLang="zh-CN" sz="14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MT1, p65, and CitH3 protein Levels. (n = 4). 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5A49ECB-1338-76D2-5822-C90C3597A8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47" y="774087"/>
            <a:ext cx="6688305" cy="30145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22839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47D53A95-5A4F-02AB-ED9E-B1FA2C529D74}"/>
              </a:ext>
            </a:extLst>
          </p:cNvPr>
          <p:cNvSpPr txBox="1"/>
          <p:nvPr/>
        </p:nvSpPr>
        <p:spPr>
          <a:xfrm>
            <a:off x="12192" y="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5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1DA38D4-8393-3990-53A0-5CEC36361D0E}"/>
              </a:ext>
            </a:extLst>
          </p:cNvPr>
          <p:cNvSpPr txBox="1"/>
          <p:nvPr/>
        </p:nvSpPr>
        <p:spPr>
          <a:xfrm>
            <a:off x="494013" y="5379919"/>
            <a:ext cx="586997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5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ATRA treatment resulted in an elevation of </a:t>
            </a:r>
            <a:r>
              <a:rPr lang="en-US" altLang="zh-CN" sz="1600" b="1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glycoRNA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levels in HL60 cells. (A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Green fluorescent probe for the detection of </a:t>
            </a:r>
            <a:r>
              <a:rPr lang="en-US" altLang="zh-CN" sz="16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glycoRNA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expression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</a:t>
            </a:r>
            <a:r>
              <a:rPr lang="en-US" altLang="zh-CN" sz="1600" dirty="0" err="1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glycoRNA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MFI (n = 4).</a:t>
            </a:r>
            <a:endParaRPr lang="en-US" altLang="zh-CN" sz="1600" b="1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69245F8-77BB-1CC6-0FD6-63C81BC773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352" y="393716"/>
            <a:ext cx="6559296" cy="49740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54827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3F9EAC-E214-142C-A6CF-E86070BF14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1905E825-247A-D383-5DC4-756684057D03}"/>
              </a:ext>
            </a:extLst>
          </p:cNvPr>
          <p:cNvSpPr txBox="1"/>
          <p:nvPr/>
        </p:nvSpPr>
        <p:spPr>
          <a:xfrm>
            <a:off x="12192" y="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6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17F6620-CCEF-F846-57B6-FF5073FF462B}"/>
              </a:ext>
            </a:extLst>
          </p:cNvPr>
          <p:cNvSpPr txBox="1"/>
          <p:nvPr/>
        </p:nvSpPr>
        <p:spPr>
          <a:xfrm>
            <a:off x="494013" y="5379919"/>
            <a:ext cx="58699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6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siMT1 Release profile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endParaRPr lang="en-US" altLang="zh-CN" sz="1600" b="1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FF12DE4-59E9-5BA6-41FC-3786183C95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332" y="777542"/>
            <a:ext cx="6319336" cy="1825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33119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A5C744-211C-EF46-3880-E592C4D4DE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C60ACAA-362A-87FA-CE7D-1C80ED07FDF9}"/>
              </a:ext>
            </a:extLst>
          </p:cNvPr>
          <p:cNvSpPr txBox="1"/>
          <p:nvPr/>
        </p:nvSpPr>
        <p:spPr>
          <a:xfrm>
            <a:off x="12192" y="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7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7637E47-0911-FEAF-A6B5-8A7B3568B7E8}"/>
              </a:ext>
            </a:extLst>
          </p:cNvPr>
          <p:cNvSpPr txBox="1"/>
          <p:nvPr/>
        </p:nvSpPr>
        <p:spPr>
          <a:xfrm>
            <a:off x="347241" y="7449118"/>
            <a:ext cx="58699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7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Internalization of NPs was performed in neutrophil. </a:t>
            </a:r>
            <a:endParaRPr lang="en-US" altLang="zh-CN" sz="1600" b="1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A8DEE88-5A4A-F788-D11F-910614D658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916" y="578735"/>
            <a:ext cx="5736624" cy="6673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4597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4B5293C-9CF3-889C-9753-A94E23229B45}"/>
              </a:ext>
            </a:extLst>
          </p:cNvPr>
          <p:cNvSpPr txBox="1"/>
          <p:nvPr/>
        </p:nvSpPr>
        <p:spPr>
          <a:xfrm>
            <a:off x="12192" y="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8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95EA1A0-0736-D9C0-DF04-B827A9E1F798}"/>
              </a:ext>
            </a:extLst>
          </p:cNvPr>
          <p:cNvSpPr txBox="1"/>
          <p:nvPr/>
        </p:nvSpPr>
        <p:spPr>
          <a:xfrm>
            <a:off x="494013" y="7578148"/>
            <a:ext cx="5869974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8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GlycoRNA-NP-siMT1 inhibits phenotypic switching in vascular smooth muscle cells.(A)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Western Blot analysis of MT1 protein expression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MT1 protein Levels. (n = 4)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Collagen deposition detected by Masson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staining. </a:t>
            </a:r>
            <a:r>
              <a:rPr lang="en-US" altLang="zh-CN" sz="16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(C)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Western Blot analysis of α-SMA, SM22a,</a:t>
            </a:r>
            <a:r>
              <a:rPr lang="zh-CN" altLang="en-US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MMP2,MMP9,</a:t>
            </a:r>
            <a:r>
              <a:rPr lang="zh-CN" altLang="en-US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OPN,</a:t>
            </a:r>
            <a:r>
              <a:rPr lang="zh-CN" altLang="en-US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and</a:t>
            </a:r>
            <a:r>
              <a:rPr lang="zh-CN" altLang="en-US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Vimentin protein expression. (n = 4)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E979116-E790-F2E1-16CF-CCAD506D64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5121"/>
          <a:stretch/>
        </p:blipFill>
        <p:spPr>
          <a:xfrm>
            <a:off x="238911" y="546100"/>
            <a:ext cx="6380178" cy="675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45096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CF2344-5A7D-F66F-1727-A268D6E30D1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CF87563-6F7B-5ADD-8C7E-E4A4E78CE410}"/>
              </a:ext>
            </a:extLst>
          </p:cNvPr>
          <p:cNvSpPr txBox="1"/>
          <p:nvPr/>
        </p:nvSpPr>
        <p:spPr>
          <a:xfrm>
            <a:off x="12192" y="1219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9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0957FEA-8A62-BD28-BCB3-5CA791391D69}"/>
              </a:ext>
            </a:extLst>
          </p:cNvPr>
          <p:cNvSpPr txBox="1"/>
          <p:nvPr/>
        </p:nvSpPr>
        <p:spPr>
          <a:xfrm>
            <a:off x="494013" y="7578148"/>
            <a:ext cx="5869974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Supplementary Figure 9</a:t>
            </a:r>
            <a:r>
              <a:rPr lang="en-US" altLang="zh-CN" sz="1600" b="1" dirty="0"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</a:t>
            </a:r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reatment with GlycoRNA-NP-siMT1 prevents AAA progression. (A)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epresentative image of the sacrificed aortas from Ang II induced AAA mice. </a:t>
            </a:r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(B)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the maximum aortic diameter</a:t>
            </a:r>
            <a:r>
              <a:rPr lang="en-US" altLang="zh-CN" sz="18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 (C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Representative image of the sacrificed aortas from Cacl2 induced AAA mice. 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 (D) </a:t>
            </a:r>
            <a:r>
              <a:rPr lang="en-US" altLang="zh-CN" sz="1600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Quantification of the maximum aortic diameter</a:t>
            </a:r>
            <a:r>
              <a:rPr lang="en-US" altLang="zh-CN" sz="1600" b="1" dirty="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.</a:t>
            </a:r>
            <a:endParaRPr lang="en-US" altLang="zh-CN" sz="1600" kern="10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4CC0786-2177-1940-7EB9-D99402AB46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00" y="511970"/>
            <a:ext cx="6654800" cy="66641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9936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2</TotalTime>
  <Words>535</Words>
  <Application>Microsoft Office PowerPoint</Application>
  <PresentationFormat>A4 纸张(210x297 毫米)</PresentationFormat>
  <Paragraphs>21</Paragraphs>
  <Slides>1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腾 马</dc:creator>
  <cp:lastModifiedBy>腾 马</cp:lastModifiedBy>
  <cp:revision>17</cp:revision>
  <dcterms:created xsi:type="dcterms:W3CDTF">2024-10-10T01:57:52Z</dcterms:created>
  <dcterms:modified xsi:type="dcterms:W3CDTF">2025-02-13T01:49:23Z</dcterms:modified>
</cp:coreProperties>
</file>